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wmf" ContentType="image/x-w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62" r:id="rId4"/>
  </p:sldIdLst>
  <p:sldSz cx="6858000" cy="9144000" type="screen4x3"/>
  <p:notesSz cx="7099300" cy="102346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 horzBarState="maximized">
    <p:restoredLeft sz="15620"/>
    <p:restoredTop sz="94660"/>
  </p:normalViewPr>
  <p:slideViewPr>
    <p:cSldViewPr showGuides="1">
      <p:cViewPr>
        <p:scale>
          <a:sx n="200" d="100"/>
          <a:sy n="200" d="100"/>
        </p:scale>
        <p:origin x="-648" y="4512"/>
      </p:cViewPr>
      <p:guideLst>
        <p:guide orient="horz" pos="4468"/>
        <p:guide orient="horz" pos="2064"/>
        <p:guide pos="21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13" Type="http://schemas.openxmlformats.org/officeDocument/2006/relationships/image" Target="../media/image13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w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19817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88893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38310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857793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17189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22525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54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4702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45271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7182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43333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4B4C8-1ACD-46B4-AE26-552F65183E5A}" type="datetimeFigureOut">
              <a:rPr lang="de-DE" smtClean="0"/>
              <a:t>24.04.202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BA8794-6345-4199-AE28-3FC15089F11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47355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8.emf"/><Relationship Id="rId26" Type="http://schemas.openxmlformats.org/officeDocument/2006/relationships/image" Target="../media/image12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0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oleObject" Target="../embeddings/oleObject8.bin"/><Relationship Id="rId25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20" Type="http://schemas.openxmlformats.org/officeDocument/2006/relationships/image" Target="../media/image9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24" Type="http://schemas.openxmlformats.org/officeDocument/2006/relationships/image" Target="../media/image11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23" Type="http://schemas.openxmlformats.org/officeDocument/2006/relationships/oleObject" Target="../embeddings/oleObject11.bin"/><Relationship Id="rId28" Type="http://schemas.openxmlformats.org/officeDocument/2006/relationships/image" Target="../media/image13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Relationship Id="rId22" Type="http://schemas.openxmlformats.org/officeDocument/2006/relationships/image" Target="../media/image10.emf"/><Relationship Id="rId27" Type="http://schemas.openxmlformats.org/officeDocument/2006/relationships/oleObject" Target="../embeddings/oleObject13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1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36235215"/>
              </p:ext>
            </p:extLst>
          </p:nvPr>
        </p:nvGraphicFramePr>
        <p:xfrm>
          <a:off x="137891" y="1727864"/>
          <a:ext cx="2037552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2" name="Prism 8" r:id="rId3" imgW="3864976" imgH="3073555" progId="Prism8.Document">
                  <p:embed/>
                </p:oleObj>
              </mc:Choice>
              <mc:Fallback>
                <p:oleObj name="Prism 8" r:id="rId3" imgW="3864976" imgH="3073555" progId="Prism8.Document">
                  <p:embed/>
                  <p:pic>
                    <p:nvPicPr>
                      <p:cNvPr id="0" name="Objek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7891" y="1727864"/>
                        <a:ext cx="2037552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98392780"/>
              </p:ext>
            </p:extLst>
          </p:nvPr>
        </p:nvGraphicFramePr>
        <p:xfrm>
          <a:off x="2171839" y="1727864"/>
          <a:ext cx="2051326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3" name="Prism 8" r:id="rId5" imgW="3864976" imgH="3052305" progId="Prism8.Document">
                  <p:embed/>
                </p:oleObj>
              </mc:Choice>
              <mc:Fallback>
                <p:oleObj name="Prism 8" r:id="rId5" imgW="3864976" imgH="3052305" progId="Prism8.Document">
                  <p:embed/>
                  <p:pic>
                    <p:nvPicPr>
                      <p:cNvPr id="0" name="Objek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71839" y="1727864"/>
                        <a:ext cx="2051326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73213288"/>
              </p:ext>
            </p:extLst>
          </p:nvPr>
        </p:nvGraphicFramePr>
        <p:xfrm>
          <a:off x="4221091" y="1727864"/>
          <a:ext cx="2049185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4" name="Prism 8" r:id="rId7" imgW="3864976" imgH="3055547" progId="Prism8.Document">
                  <p:embed/>
                </p:oleObj>
              </mc:Choice>
              <mc:Fallback>
                <p:oleObj name="Prism 8" r:id="rId7" imgW="3864976" imgH="3055547" progId="Prism8.Document">
                  <p:embed/>
                  <p:pic>
                    <p:nvPicPr>
                      <p:cNvPr id="0" name="Objek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21091" y="1727864"/>
                        <a:ext cx="2049185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59926"/>
              </p:ext>
            </p:extLst>
          </p:nvPr>
        </p:nvGraphicFramePr>
        <p:xfrm>
          <a:off x="139142" y="3299671"/>
          <a:ext cx="2040715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5" name="Prism 8" r:id="rId9" imgW="3864976" imgH="3069233" progId="Prism8.Document">
                  <p:embed/>
                </p:oleObj>
              </mc:Choice>
              <mc:Fallback>
                <p:oleObj name="Prism 8" r:id="rId9" imgW="3864976" imgH="3069233" progId="Prism8.Document">
                  <p:embed/>
                  <p:pic>
                    <p:nvPicPr>
                      <p:cNvPr id="0" name="Objek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9142" y="3299671"/>
                        <a:ext cx="2040715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78046380"/>
              </p:ext>
            </p:extLst>
          </p:nvPr>
        </p:nvGraphicFramePr>
        <p:xfrm>
          <a:off x="2174878" y="3300144"/>
          <a:ext cx="2052858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6" name="Prism 8" r:id="rId11" imgW="3863160" imgH="3046320" progId="Prism8.Document">
                  <p:embed/>
                </p:oleObj>
              </mc:Choice>
              <mc:Fallback>
                <p:oleObj name="Prism 8" r:id="rId11" imgW="3863160" imgH="3046320" progId="Prism8.Document">
                  <p:embed/>
                  <p:pic>
                    <p:nvPicPr>
                      <p:cNvPr id="0" name="Objekt 6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174878" y="3300144"/>
                        <a:ext cx="2052858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1498835"/>
              </p:ext>
            </p:extLst>
          </p:nvPr>
        </p:nvGraphicFramePr>
        <p:xfrm>
          <a:off x="4224546" y="3304634"/>
          <a:ext cx="2040715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7" name="Prism 8" r:id="rId13" imgW="3864976" imgH="3069233" progId="Prism8.Document">
                  <p:embed/>
                </p:oleObj>
              </mc:Choice>
              <mc:Fallback>
                <p:oleObj name="Prism 8" r:id="rId13" imgW="3864976" imgH="3069233" progId="Prism8.Document">
                  <p:embed/>
                  <p:pic>
                    <p:nvPicPr>
                      <p:cNvPr id="0" name="Objek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24546" y="3304634"/>
                        <a:ext cx="2040715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feld 7"/>
          <p:cNvSpPr txBox="1"/>
          <p:nvPr/>
        </p:nvSpPr>
        <p:spPr>
          <a:xfrm>
            <a:off x="0" y="1605939"/>
            <a:ext cx="44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B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-3569" y="4812402"/>
            <a:ext cx="44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C</a:t>
            </a:r>
          </a:p>
        </p:txBody>
      </p:sp>
      <p:graphicFrame>
        <p:nvGraphicFramePr>
          <p:cNvPr id="20" name="Objekt 1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299194"/>
              </p:ext>
            </p:extLst>
          </p:nvPr>
        </p:nvGraphicFramePr>
        <p:xfrm>
          <a:off x="134565" y="4872681"/>
          <a:ext cx="2054285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8" name="Prism 8" r:id="rId15" imgW="3864976" imgH="3047623" progId="Prism8.Document">
                  <p:embed/>
                </p:oleObj>
              </mc:Choice>
              <mc:Fallback>
                <p:oleObj name="Prism 8" r:id="rId15" imgW="3864976" imgH="3047623" progId="Prism8.Document">
                  <p:embed/>
                  <p:pic>
                    <p:nvPicPr>
                      <p:cNvPr id="0" name="Objek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34565" y="4872681"/>
                        <a:ext cx="2054285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" name="Objekt 2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6005677"/>
              </p:ext>
            </p:extLst>
          </p:nvPr>
        </p:nvGraphicFramePr>
        <p:xfrm>
          <a:off x="2225109" y="4884410"/>
          <a:ext cx="1951429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79" name="Prism 8" r:id="rId17" imgW="3864976" imgH="3044742" progId="Prism8.Document">
                  <p:embed/>
                </p:oleObj>
              </mc:Choice>
              <mc:Fallback>
                <p:oleObj name="Prism 8" r:id="rId17" imgW="3864976" imgH="3044742" progId="Prism8.Document">
                  <p:embed/>
                  <p:pic>
                    <p:nvPicPr>
                      <p:cNvPr id="0" name="Objek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25109" y="4884410"/>
                        <a:ext cx="1951429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k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2026025"/>
              </p:ext>
            </p:extLst>
          </p:nvPr>
        </p:nvGraphicFramePr>
        <p:xfrm>
          <a:off x="4239018" y="4878268"/>
          <a:ext cx="1947142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80" name="Prism 8" r:id="rId19" imgW="3864976" imgH="3059869" progId="Prism8.Document">
                  <p:embed/>
                </p:oleObj>
              </mc:Choice>
              <mc:Fallback>
                <p:oleObj name="Prism 8" r:id="rId19" imgW="3864976" imgH="3059869" progId="Prism8.Document">
                  <p:embed/>
                  <p:pic>
                    <p:nvPicPr>
                      <p:cNvPr id="0" name="Objekt 3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239018" y="4878268"/>
                        <a:ext cx="1947142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" name="Objekt 2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8865457"/>
              </p:ext>
            </p:extLst>
          </p:nvPr>
        </p:nvGraphicFramePr>
        <p:xfrm>
          <a:off x="161927" y="6456415"/>
          <a:ext cx="1917144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81" name="Prism 8" r:id="rId21" imgW="3864976" imgH="3047623" progId="Prism8.Document">
                  <p:embed/>
                </p:oleObj>
              </mc:Choice>
              <mc:Fallback>
                <p:oleObj name="Prism 8" r:id="rId21" imgW="3864976" imgH="3047623" progId="Prism8.Document">
                  <p:embed/>
                  <p:pic>
                    <p:nvPicPr>
                      <p:cNvPr id="0" name="Objekt 4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61927" y="6456415"/>
                        <a:ext cx="1917144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Objekt 2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801679"/>
              </p:ext>
            </p:extLst>
          </p:nvPr>
        </p:nvGraphicFramePr>
        <p:xfrm>
          <a:off x="2224480" y="6466078"/>
          <a:ext cx="1951429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82" name="Prism 8" r:id="rId23" imgW="3864976" imgH="3043302" progId="Prism8.Document">
                  <p:embed/>
                </p:oleObj>
              </mc:Choice>
              <mc:Fallback>
                <p:oleObj name="Prism 8" r:id="rId23" imgW="3864976" imgH="3043302" progId="Prism8.Document">
                  <p:embed/>
                  <p:pic>
                    <p:nvPicPr>
                      <p:cNvPr id="0" name="Objek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224480" y="6466078"/>
                        <a:ext cx="1951429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feld 24"/>
          <p:cNvSpPr txBox="1"/>
          <p:nvPr/>
        </p:nvSpPr>
        <p:spPr>
          <a:xfrm>
            <a:off x="8764" y="8172400"/>
            <a:ext cx="68492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de-DE" sz="12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: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ytotoxicity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anti-PSMA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toxin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bination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1861 on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ostate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cer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D7-1(VL-V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E24mut and SO1861 on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(B) hD7-1(VL-VH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PE24mut</a:t>
            </a:r>
            <a:r>
              <a:rPr lang="el-G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Δ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LK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O1861 on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(C) C4-2 or (D) PC3 cells as measured by WST-1 viability assays. MW ± SD from three independent experiments.</a:t>
            </a:r>
            <a:endParaRPr lang="de-D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Objek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2770254"/>
              </p:ext>
            </p:extLst>
          </p:nvPr>
        </p:nvGraphicFramePr>
        <p:xfrm>
          <a:off x="4539607" y="6458497"/>
          <a:ext cx="2057745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83" name="Prism 8" r:id="rId25" imgW="3864976" imgH="3043302" progId="Prism8.Document">
                  <p:embed/>
                </p:oleObj>
              </mc:Choice>
              <mc:Fallback>
                <p:oleObj name="Prism 8" r:id="rId25" imgW="3864976" imgH="3043302" progId="Prism8.Document">
                  <p:embed/>
                  <p:pic>
                    <p:nvPicPr>
                      <p:cNvPr id="0" name="Objek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539607" y="6458497"/>
                        <a:ext cx="2057745" cy="16200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" name="Textfeld 26"/>
          <p:cNvSpPr txBox="1"/>
          <p:nvPr/>
        </p:nvSpPr>
        <p:spPr>
          <a:xfrm>
            <a:off x="4149080" y="6379245"/>
            <a:ext cx="44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D</a:t>
            </a:r>
          </a:p>
        </p:txBody>
      </p:sp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4785743"/>
              </p:ext>
            </p:extLst>
          </p:nvPr>
        </p:nvGraphicFramePr>
        <p:xfrm>
          <a:off x="134708" y="66917"/>
          <a:ext cx="2088074" cy="162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684" name="Prism 8" r:id="rId27" imgW="3901350" imgH="3027815" progId="Prism8.Document">
                  <p:embed/>
                </p:oleObj>
              </mc:Choice>
              <mc:Fallback>
                <p:oleObj name="Prism 8" r:id="rId27" imgW="3901350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34708" y="66917"/>
                        <a:ext cx="2088074" cy="162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Textfeld 18"/>
          <p:cNvSpPr txBox="1"/>
          <p:nvPr/>
        </p:nvSpPr>
        <p:spPr>
          <a:xfrm>
            <a:off x="-3569" y="-4610"/>
            <a:ext cx="44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256186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" name="Gruppieren 24"/>
          <p:cNvGrpSpPr/>
          <p:nvPr/>
        </p:nvGrpSpPr>
        <p:grpSpPr>
          <a:xfrm>
            <a:off x="1744238" y="2017816"/>
            <a:ext cx="1496962" cy="288032"/>
            <a:chOff x="467544" y="2780928"/>
            <a:chExt cx="1496962" cy="288032"/>
          </a:xfrm>
        </p:grpSpPr>
        <p:sp>
          <p:nvSpPr>
            <p:cNvPr id="36" name="Rechteck 35"/>
            <p:cNvSpPr/>
            <p:nvPr/>
          </p:nvSpPr>
          <p:spPr>
            <a:xfrm>
              <a:off x="498800" y="2780928"/>
              <a:ext cx="1465706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7-1(VL-VH)-PE24mut</a:t>
              </a:r>
              <a:r>
                <a:rPr lang="el-GR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LK</a:t>
              </a:r>
              <a:endParaRPr lang="de-DE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Gleichschenkliges Dreieck 36"/>
            <p:cNvSpPr>
              <a:spLocks noChangeAspect="1"/>
            </p:cNvSpPr>
            <p:nvPr/>
          </p:nvSpPr>
          <p:spPr>
            <a:xfrm>
              <a:off x="467544" y="2887869"/>
              <a:ext cx="80663" cy="75600"/>
            </a:xfrm>
            <a:prstGeom prst="triangle">
              <a:avLst/>
            </a:prstGeom>
            <a:solidFill>
              <a:srgbClr val="0000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26" name="Gruppieren 25"/>
          <p:cNvGrpSpPr/>
          <p:nvPr/>
        </p:nvGrpSpPr>
        <p:grpSpPr>
          <a:xfrm>
            <a:off x="2499397" y="1835696"/>
            <a:ext cx="641571" cy="288032"/>
            <a:chOff x="2869694" y="2780928"/>
            <a:chExt cx="641571" cy="288032"/>
          </a:xfrm>
        </p:grpSpPr>
        <p:sp>
          <p:nvSpPr>
            <p:cNvPr id="32" name="Rechteck 31"/>
            <p:cNvSpPr/>
            <p:nvPr/>
          </p:nvSpPr>
          <p:spPr>
            <a:xfrm>
              <a:off x="2981466" y="2780928"/>
              <a:ext cx="529799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1861</a:t>
              </a:r>
              <a:endParaRPr lang="de-DE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Gerade Verbindung 33"/>
            <p:cNvCxnSpPr/>
            <p:nvPr/>
          </p:nvCxnSpPr>
          <p:spPr>
            <a:xfrm>
              <a:off x="2869694" y="2929287"/>
              <a:ext cx="144016" cy="0"/>
            </a:xfrm>
            <a:prstGeom prst="line">
              <a:avLst/>
            </a:prstGeom>
            <a:solidFill>
              <a:schemeClr val="tx1"/>
            </a:solidFill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uppieren 26"/>
          <p:cNvGrpSpPr/>
          <p:nvPr/>
        </p:nvGrpSpPr>
        <p:grpSpPr>
          <a:xfrm>
            <a:off x="1340768" y="2195736"/>
            <a:ext cx="2035276" cy="288032"/>
            <a:chOff x="3851920" y="2785690"/>
            <a:chExt cx="2866125" cy="288032"/>
          </a:xfrm>
        </p:grpSpPr>
        <p:sp>
          <p:nvSpPr>
            <p:cNvPr id="28" name="Rechteck 27"/>
            <p:cNvSpPr/>
            <p:nvPr/>
          </p:nvSpPr>
          <p:spPr>
            <a:xfrm>
              <a:off x="3955997" y="2785690"/>
              <a:ext cx="2762048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7-1(VL-VH)-PE24mut</a:t>
              </a:r>
              <a:r>
                <a:rPr lang="el-GR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LK + SO1861</a:t>
              </a:r>
              <a:endParaRPr lang="de-DE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Gerade Verbindung 29"/>
            <p:cNvCxnSpPr/>
            <p:nvPr/>
          </p:nvCxnSpPr>
          <p:spPr>
            <a:xfrm>
              <a:off x="3851920" y="2932087"/>
              <a:ext cx="144016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38" name="Tabelle 3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94029067"/>
              </p:ext>
            </p:extLst>
          </p:nvPr>
        </p:nvGraphicFramePr>
        <p:xfrm>
          <a:off x="143221" y="2627784"/>
          <a:ext cx="3002351" cy="34747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7389"/>
                <a:gridCol w="2704962"/>
              </a:tblGrid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  <a:r>
                        <a:rPr lang="el-G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LK + 2.5 µg/ml SO1861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  <a:r>
                        <a:rPr lang="el-G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LK + 1.25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  <a:r>
                        <a:rPr lang="el-G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LK + 1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  <a:r>
                        <a:rPr lang="el-G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LK + 0.9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  <a:r>
                        <a:rPr lang="el-G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LK + 0.8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  <a:r>
                        <a:rPr lang="el-G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LK</a:t>
                      </a:r>
                      <a:r>
                        <a:rPr lang="de-DE" sz="6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0.63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  <a:r>
                        <a:rPr lang="el-GR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Δ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DLK + 0.31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5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 µg/ml SO1861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0">
                <a:tc>
                  <a:txBody>
                    <a:bodyPr/>
                    <a:lstStyle/>
                    <a:p>
                      <a:pPr algn="r"/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)</a:t>
                      </a:r>
                      <a:endParaRPr lang="de-DE" sz="6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 </a:t>
                      </a:r>
                      <a:r>
                        <a:rPr lang="de-DE" sz="600" dirty="0" err="1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M</a:t>
                      </a:r>
                      <a:r>
                        <a:rPr lang="de-DE" sz="6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hD7-1(VL-VH)-PE24mut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39" name="Textfeld 38"/>
          <p:cNvSpPr txBox="1"/>
          <p:nvPr/>
        </p:nvSpPr>
        <p:spPr>
          <a:xfrm>
            <a:off x="4763" y="4631"/>
            <a:ext cx="44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40" name="Textfeld 39"/>
          <p:cNvSpPr txBox="1"/>
          <p:nvPr/>
        </p:nvSpPr>
        <p:spPr>
          <a:xfrm>
            <a:off x="3197770" y="7152"/>
            <a:ext cx="44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/>
              <a:t>B</a:t>
            </a:r>
          </a:p>
        </p:txBody>
      </p:sp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7269" y="2920956"/>
            <a:ext cx="2995308" cy="122709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7" name="Gruppieren 46"/>
          <p:cNvGrpSpPr/>
          <p:nvPr/>
        </p:nvGrpSpPr>
        <p:grpSpPr>
          <a:xfrm>
            <a:off x="5128614" y="2017816"/>
            <a:ext cx="1496962" cy="288032"/>
            <a:chOff x="467544" y="2780928"/>
            <a:chExt cx="1496962" cy="288032"/>
          </a:xfrm>
        </p:grpSpPr>
        <p:sp>
          <p:nvSpPr>
            <p:cNvPr id="48" name="Rechteck 47"/>
            <p:cNvSpPr/>
            <p:nvPr/>
          </p:nvSpPr>
          <p:spPr>
            <a:xfrm>
              <a:off x="498800" y="2780928"/>
              <a:ext cx="1465706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7-1(VL-VH)-PE24mut</a:t>
              </a:r>
              <a:r>
                <a:rPr lang="el-GR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LK</a:t>
              </a:r>
              <a:endParaRPr lang="de-DE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Gleichschenkliges Dreieck 48"/>
            <p:cNvSpPr>
              <a:spLocks noChangeAspect="1"/>
            </p:cNvSpPr>
            <p:nvPr/>
          </p:nvSpPr>
          <p:spPr>
            <a:xfrm>
              <a:off x="467544" y="2887869"/>
              <a:ext cx="80663" cy="75600"/>
            </a:xfrm>
            <a:prstGeom prst="triangle">
              <a:avLst/>
            </a:prstGeom>
            <a:solidFill>
              <a:srgbClr val="000099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 sz="6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uppieren 49"/>
          <p:cNvGrpSpPr/>
          <p:nvPr/>
        </p:nvGrpSpPr>
        <p:grpSpPr>
          <a:xfrm>
            <a:off x="5883773" y="1835696"/>
            <a:ext cx="641571" cy="288032"/>
            <a:chOff x="2869694" y="2780928"/>
            <a:chExt cx="641571" cy="288032"/>
          </a:xfrm>
        </p:grpSpPr>
        <p:sp>
          <p:nvSpPr>
            <p:cNvPr id="51" name="Rechteck 50"/>
            <p:cNvSpPr/>
            <p:nvPr/>
          </p:nvSpPr>
          <p:spPr>
            <a:xfrm>
              <a:off x="2981466" y="2780928"/>
              <a:ext cx="529799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1861</a:t>
              </a:r>
              <a:endParaRPr lang="de-DE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Gerade Verbindung 51"/>
            <p:cNvCxnSpPr/>
            <p:nvPr/>
          </p:nvCxnSpPr>
          <p:spPr>
            <a:xfrm>
              <a:off x="2869694" y="2929287"/>
              <a:ext cx="144016" cy="0"/>
            </a:xfrm>
            <a:prstGeom prst="line">
              <a:avLst/>
            </a:prstGeom>
            <a:solidFill>
              <a:schemeClr val="tx1"/>
            </a:solidFill>
            <a:ln w="19050">
              <a:solidFill>
                <a:srgbClr val="7030A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3" name="Gruppieren 52"/>
          <p:cNvGrpSpPr/>
          <p:nvPr/>
        </p:nvGrpSpPr>
        <p:grpSpPr>
          <a:xfrm>
            <a:off x="4725144" y="2195736"/>
            <a:ext cx="2035276" cy="288032"/>
            <a:chOff x="3851920" y="2785690"/>
            <a:chExt cx="2866125" cy="288032"/>
          </a:xfrm>
        </p:grpSpPr>
        <p:sp>
          <p:nvSpPr>
            <p:cNvPr id="54" name="Rechteck 53"/>
            <p:cNvSpPr/>
            <p:nvPr/>
          </p:nvSpPr>
          <p:spPr>
            <a:xfrm>
              <a:off x="3955997" y="2785690"/>
              <a:ext cx="2762048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D7-1(VL-VH)-PE24mut</a:t>
              </a:r>
              <a:r>
                <a:rPr lang="el-GR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Δ</a:t>
              </a:r>
              <a:r>
                <a:rPr lang="de-DE" sz="600" dirty="0" smtClean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DLK + SO1861</a:t>
              </a:r>
              <a:endParaRPr lang="de-DE" sz="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5" name="Gerade Verbindung 54"/>
            <p:cNvCxnSpPr/>
            <p:nvPr/>
          </p:nvCxnSpPr>
          <p:spPr>
            <a:xfrm>
              <a:off x="3851920" y="2932087"/>
              <a:ext cx="144016" cy="0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6" name="Textfeld 55"/>
          <p:cNvSpPr txBox="1"/>
          <p:nvPr/>
        </p:nvSpPr>
        <p:spPr>
          <a:xfrm>
            <a:off x="3198687" y="2555776"/>
            <a:ext cx="4472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dirty="0" smtClean="0"/>
              <a:t>C</a:t>
            </a:r>
            <a:endParaRPr lang="de-DE" dirty="0"/>
          </a:p>
        </p:txBody>
      </p:sp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73016" y="45022"/>
            <a:ext cx="3086396" cy="25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6270" y="50064"/>
            <a:ext cx="2886912" cy="255502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9" name="Textfeld 28"/>
          <p:cNvSpPr txBox="1"/>
          <p:nvPr/>
        </p:nvSpPr>
        <p:spPr>
          <a:xfrm>
            <a:off x="161601" y="6228184"/>
            <a:ext cx="573112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de-DE" sz="12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2: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rapeutic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ndow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hD7-1(VL-VH</a:t>
            </a:r>
            <a:r>
              <a:rPr lang="de-DE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-PE24mut 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bination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1861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n 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de-DE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4-2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75%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90%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pecificity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rapeutic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indows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O1861 on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NCaP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and C4-2 </a:t>
            </a:r>
            <a:r>
              <a:rPr lang="de-DE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117167548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333375" y="2165539"/>
            <a:ext cx="62639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de-DE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u="sng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de-DE" sz="1200" u="sng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3:</a:t>
            </a:r>
            <a:r>
              <a:rPr lang="de-DE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hange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dy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weight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nimals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eatment</a:t>
            </a:r>
            <a:r>
              <a:rPr lang="de-DE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de-DE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20838845"/>
              </p:ext>
            </p:extLst>
          </p:nvPr>
        </p:nvGraphicFramePr>
        <p:xfrm>
          <a:off x="232651" y="323728"/>
          <a:ext cx="4103875" cy="180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9" name="Prism 8" r:id="rId3" imgW="5986896" imgH="2625523" progId="Prism8.Document">
                  <p:embed/>
                </p:oleObj>
              </mc:Choice>
              <mc:Fallback>
                <p:oleObj name="Prism 8" r:id="rId3" imgW="5986896" imgH="262552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2651" y="323728"/>
                        <a:ext cx="4103875" cy="180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613329015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5</Words>
  <Application>Microsoft Office PowerPoint</Application>
  <PresentationFormat>Bildschirmpräsentation (4:3)</PresentationFormat>
  <Paragraphs>54</Paragraphs>
  <Slides>3</Slides>
  <Notes>0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3</vt:i4>
      </vt:variant>
    </vt:vector>
  </HeadingPairs>
  <TitlesOfParts>
    <vt:vector size="5" baseType="lpstr">
      <vt:lpstr>Larissa</vt:lpstr>
      <vt:lpstr>Prism 8</vt:lpstr>
      <vt:lpstr>PowerPoint-Präsentation</vt:lpstr>
      <vt:lpstr>PowerPoint-Präsentation</vt:lpstr>
      <vt:lpstr>PowerPoint-Präsentation</vt:lpstr>
    </vt:vector>
  </TitlesOfParts>
  <Company>Uniklinikum Freibu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Prof. Dr. Philipp Wolf</dc:creator>
  <cp:lastModifiedBy>Prof. Dr. Philipp Wolf</cp:lastModifiedBy>
  <cp:revision>76</cp:revision>
  <cp:lastPrinted>2023-04-11T12:18:09Z</cp:lastPrinted>
  <dcterms:created xsi:type="dcterms:W3CDTF">2023-03-15T09:30:02Z</dcterms:created>
  <dcterms:modified xsi:type="dcterms:W3CDTF">2023-04-24T08:24:34Z</dcterms:modified>
</cp:coreProperties>
</file>